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58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1" d="100"/>
          <a:sy n="81" d="100"/>
        </p:scale>
        <p:origin x="1498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25902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02181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44893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7142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71363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07097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40620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1212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26499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58826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6228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4A3B6-E69D-4AE8-B62C-305728F9D81F}" type="datetimeFigureOut">
              <a:rPr lang="ko-KR" altLang="en-US" smtClean="0"/>
              <a:t>2022-07-1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6B6D3-26B4-4144-89DD-5190BAA139B5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5197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sp>
            <p:nvSpPr>
              <p:cNvPr id="8" name="TextBox 7"/>
              <p:cNvSpPr txBox="1"/>
              <p:nvPr/>
            </p:nvSpPr>
            <p:spPr>
              <a:xfrm>
                <a:off x="144344" y="4880735"/>
                <a:ext cx="8856984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1. </a:t>
                </a:r>
                <a:r>
                  <a:rPr lang="en-US" altLang="ko-KR" sz="1400" dirty="0"/>
                  <a:t>Differential induction of VDUP1 expression in various human cancer cell lines. Human cancer cells (A549, PC-3, MM231, AGS, HepG2) were transfected with dsVDUP1-834 for 96 h. The mRNA expression of VDUP1 was determined by </a:t>
                </a:r>
                <a:r>
                  <a:rPr lang="en-US" altLang="ko-KR" sz="1400" dirty="0" err="1"/>
                  <a:t>qRT</a:t>
                </a:r>
                <a:r>
                  <a:rPr lang="en-US" altLang="ko-KR" sz="1400" dirty="0"/>
                  <a:t>-PCR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8" name="TextBox 7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4880735"/>
                <a:ext cx="8856984" cy="954107"/>
              </a:xfrm>
              <a:prstGeom prst="rect">
                <a:avLst/>
              </a:prstGeom>
              <a:blipFill>
                <a:blip r:embed="rId2"/>
                <a:stretch>
                  <a:fillRect l="-206" t="-1282" r="-206" b="-576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9" name="그룹 8"/>
          <p:cNvGrpSpPr/>
          <p:nvPr/>
        </p:nvGrpSpPr>
        <p:grpSpPr>
          <a:xfrm>
            <a:off x="2256169" y="1378070"/>
            <a:ext cx="4651780" cy="2506128"/>
            <a:chOff x="2292484" y="1880558"/>
            <a:chExt cx="4651780" cy="2506128"/>
          </a:xfrm>
        </p:grpSpPr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10" t="29443" r="1921" b="8469"/>
            <a:stretch/>
          </p:blipFill>
          <p:spPr bwMode="auto">
            <a:xfrm>
              <a:off x="2717321" y="1880558"/>
              <a:ext cx="4226943" cy="2087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3445750" y="3925021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/>
                <a:t>Mock</a:t>
              </a:r>
              <a:endParaRPr lang="ko-KR" altLang="en-US" sz="12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72000" y="3925021"/>
              <a:ext cx="119936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/>
                <a:t>dsVDUP1-834</a:t>
              </a:r>
            </a:p>
            <a:p>
              <a:pPr algn="ctr"/>
              <a:r>
                <a:rPr lang="en-US" altLang="ko-KR" sz="1200" b="1" dirty="0"/>
                <a:t>(10 nM)</a:t>
              </a:r>
              <a:endParaRPr lang="ko-KR" altLang="en-US" sz="12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1726603" y="2703253"/>
              <a:ext cx="1593412" cy="461649"/>
            </a:xfrm>
            <a:prstGeom prst="rect">
              <a:avLst/>
            </a:prstGeom>
            <a:noFill/>
          </p:spPr>
          <p:txBody>
            <a:bodyPr wrap="none" lIns="91422" tIns="45712" rIns="91422" bIns="45712" rtlCol="0">
              <a:spAutoFit/>
            </a:bodyPr>
            <a:lstStyle/>
            <a:p>
              <a:pPr algn="ctr"/>
              <a:r>
                <a:rPr lang="en-US" altLang="ko-KR" sz="1200" b="1" dirty="0"/>
                <a:t>Relative expression</a:t>
              </a:r>
            </a:p>
            <a:p>
              <a:pPr algn="ctr"/>
              <a:r>
                <a:rPr lang="en-US" altLang="ko-KR" sz="1200" b="1" dirty="0"/>
                <a:t>(VDUP-1/</a:t>
              </a:r>
              <a:r>
                <a:rPr lang="en-US" altLang="ko-KR" sz="1200" b="1" dirty="0">
                  <a:latin typeface="Symbol" panose="05050102010706020507" pitchFamily="18" charset="2"/>
                </a:rPr>
                <a:t>b</a:t>
              </a:r>
              <a:r>
                <a:rPr lang="en-US" altLang="ko-KR" sz="1200" b="1" dirty="0"/>
                <a:t>-actin)</a:t>
              </a:r>
              <a:endParaRPr lang="ko-KR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6146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9281" y="1646315"/>
            <a:ext cx="2901129" cy="1746848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918079" y="3316517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486871" y="3466396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228789" y="3614827"/>
            <a:ext cx="15808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-MM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48889" y="33165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122622" y="33165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38608" y="346639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97848" y="33165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901729" y="346639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913863" y="33165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254413" y="34663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682288" y="33165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685342" y="346639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170744" y="346639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173641" y="361482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552233" y="361482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915898" y="361482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304631" y="361482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641213" y="36148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637846" y="3463879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936715" y="2265510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01540" y="1866230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34" name="TextBox 33"/>
              <p:cNvSpPr txBox="1"/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2. </a:t>
                </a:r>
                <a:r>
                  <a:rPr lang="en-US" altLang="ko-KR" sz="1400" dirty="0"/>
                  <a:t>dsVDUP1-834 transfection induces VDUP1 expression in A549 cells. A549 cells were transfected with </a:t>
                </a:r>
                <a:r>
                  <a:rPr lang="en-US" altLang="ko-KR" sz="1400" dirty="0" err="1"/>
                  <a:t>dsCon</a:t>
                </a:r>
                <a:r>
                  <a:rPr lang="en-US" altLang="ko-KR" sz="1400" dirty="0"/>
                  <a:t> or indicated concentrations of </a:t>
                </a:r>
                <a:r>
                  <a:rPr lang="en-US" altLang="ko-KR" sz="1400" dirty="0" err="1"/>
                  <a:t>saRNAs</a:t>
                </a:r>
                <a:r>
                  <a:rPr lang="en-US" altLang="ko-KR" sz="1400" dirty="0"/>
                  <a:t> for 96 h. The protein expression of VDUP1 was assessed by Western immunoblot analysis. The band intensities were quantified by </a:t>
                </a:r>
                <a:r>
                  <a:rPr lang="en-US" altLang="ko-KR" sz="1400" dirty="0" err="1"/>
                  <a:t>ImageJ</a:t>
                </a:r>
                <a:r>
                  <a:rPr lang="en-US" altLang="ko-KR" sz="1400" dirty="0"/>
                  <a:t> 1.53a and normalized by that of </a:t>
                </a:r>
                <a:r>
                  <a:rPr lang="en-US" altLang="ko-KR" sz="1400" dirty="0">
                    <a:latin typeface="Symbol" panose="05050102010706020507" pitchFamily="18" charset="2"/>
                  </a:rPr>
                  <a:t>b</a:t>
                </a:r>
                <a:r>
                  <a:rPr lang="en-US" altLang="ko-KR" sz="1400" dirty="0"/>
                  <a:t>-actin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 * denotes that the response is significantly different from mock-treated group as determined by </a:t>
                </a:r>
                <a:r>
                  <a:rPr lang="en-US" altLang="ko-KR" sz="1400" dirty="0" err="1"/>
                  <a:t>Dunnett’s</a:t>
                </a:r>
                <a:r>
                  <a:rPr lang="en-US" altLang="ko-KR" sz="1400" dirty="0"/>
                  <a:t> t-test at p&lt;0.05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34" name="TextBox 3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blipFill>
                <a:blip r:embed="rId3"/>
                <a:stretch>
                  <a:fillRect l="-206" t="-881" r="-206" b="-35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613114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24150" y="1280335"/>
            <a:ext cx="3695700" cy="2790825"/>
          </a:xfrm>
          <a:prstGeom prst="rect">
            <a:avLst/>
          </a:prstGeom>
        </p:spPr>
      </p:pic>
      <mc:AlternateContent xmlns:mc="http://schemas.openxmlformats.org/markup-compatibility/2006">
        <mc:Choice xmlns:a14="http://schemas.microsoft.com/office/drawing/2010/main" Requires="a14">
          <p:sp>
            <p:nvSpPr>
              <p:cNvPr id="4" name="TextBox 3"/>
              <p:cNvSpPr txBox="1"/>
              <p:nvPr/>
            </p:nvSpPr>
            <p:spPr>
              <a:xfrm>
                <a:off x="144344" y="4880735"/>
                <a:ext cx="8856984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3. </a:t>
                </a:r>
                <a:r>
                  <a:rPr lang="en-US" altLang="ko-KR" sz="1400" dirty="0"/>
                  <a:t>dsVDUP1-834 transfection inhibits cell growth in PC-3 cells. PC-3 cells were transfected with </a:t>
                </a:r>
                <a:r>
                  <a:rPr lang="en-US" altLang="ko-KR" sz="1400" dirty="0" err="1"/>
                  <a:t>dsCon</a:t>
                </a:r>
                <a:r>
                  <a:rPr lang="en-US" altLang="ko-KR" sz="1400" dirty="0"/>
                  <a:t> or indicated concentrations of </a:t>
                </a:r>
                <a:r>
                  <a:rPr lang="en-US" altLang="ko-KR" sz="1400" dirty="0" err="1"/>
                  <a:t>saRNAs</a:t>
                </a:r>
                <a:r>
                  <a:rPr lang="en-US" altLang="ko-KR" sz="1400" dirty="0"/>
                  <a:t> for 96 h and cell proliferation was measured by XTT assay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4" name="TextBox 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4880735"/>
                <a:ext cx="8856984" cy="738664"/>
              </a:xfrm>
              <a:prstGeom prst="rect">
                <a:avLst/>
              </a:prstGeom>
              <a:blipFill>
                <a:blip r:embed="rId3"/>
                <a:stretch>
                  <a:fillRect l="-206" t="-1653" r="-206" b="-7438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3943631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1228" y="379232"/>
            <a:ext cx="2728404" cy="1772914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6433" y="422248"/>
            <a:ext cx="2784714" cy="1756722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97862" y="2974076"/>
            <a:ext cx="2941704" cy="1886067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1207" y="3122726"/>
            <a:ext cx="2906383" cy="1711709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5261986" y="2126438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830778" y="2276317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72696" y="2424748"/>
            <a:ext cx="15808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-MM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52136" y="21264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266187" y="212643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222752" y="22763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829427" y="212643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832481" y="22763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700258" y="227631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703155" y="242474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272970" y="242474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88352" y="24247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5981753" y="2273800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454246" y="98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262190" y="26163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364088" y="26137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266489" y="695140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46398" y="4834435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15190" y="4984314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7108" y="5132745"/>
            <a:ext cx="15808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-MM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536548" y="48344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150599" y="483443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107164" y="49843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713839" y="483443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716893" y="4984314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584670" y="4984314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587567" y="513274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157382" y="513274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672764" y="51327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866165" y="4981797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45973" y="3959611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272865" y="4834435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841657" y="4984314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583575" y="5132745"/>
            <a:ext cx="15808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-MM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674590" y="48344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300216" y="483443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256781" y="49843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886606" y="483443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889660" y="4984314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722712" y="4984314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725609" y="513274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306999" y="5132745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845531" y="513274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5992632" y="4981797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301404" y="3757507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80849" y="2118089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49641" y="2267968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91559" y="2416399"/>
            <a:ext cx="15808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-MM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470999" y="21180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061900" y="2118089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018465" y="22679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625140" y="2118089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616619" y="226796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519121" y="2267968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522018" y="2416399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068683" y="2416399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572490" y="24163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1835341" y="2265451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279869" y="989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077641" y="564115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76" name="TextBox 75"/>
              <p:cNvSpPr txBox="1"/>
              <p:nvPr/>
            </p:nvSpPr>
            <p:spPr>
              <a:xfrm>
                <a:off x="144344" y="5439956"/>
                <a:ext cx="8856984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4. </a:t>
                </a:r>
                <a:r>
                  <a:rPr lang="en-US" altLang="ko-KR" sz="1400" dirty="0"/>
                  <a:t>The effects of dsVDUP1-834 on the expression of p27, p53, Cyclin A and Cyclin B1 in A549 cells. A549 cells were transfected with </a:t>
                </a:r>
                <a:r>
                  <a:rPr lang="en-US" altLang="ko-KR" sz="1400" dirty="0" err="1"/>
                  <a:t>dsCon</a:t>
                </a:r>
                <a:r>
                  <a:rPr lang="en-US" altLang="ko-KR" sz="1400" dirty="0"/>
                  <a:t> or indicated concentrations of </a:t>
                </a:r>
                <a:r>
                  <a:rPr lang="en-US" altLang="ko-KR" sz="1400" dirty="0" err="1"/>
                  <a:t>saRNAs</a:t>
                </a:r>
                <a:r>
                  <a:rPr lang="en-US" altLang="ko-KR" sz="1400" dirty="0"/>
                  <a:t> for 96 h. The protein expression of p27(A), p53(B), Cyclin A(C) and Cyclin B1(D) was assessed by Western immunoblot analysis. The band intensities were quantified by </a:t>
                </a:r>
                <a:r>
                  <a:rPr lang="en-US" altLang="ko-KR" sz="1400" dirty="0" err="1"/>
                  <a:t>ImageJ</a:t>
                </a:r>
                <a:r>
                  <a:rPr lang="en-US" altLang="ko-KR" sz="1400" dirty="0"/>
                  <a:t> 1.53a and normalized by that of </a:t>
                </a:r>
                <a:r>
                  <a:rPr lang="en-US" altLang="ko-KR" sz="1400" dirty="0">
                    <a:latin typeface="Symbol" panose="05050102010706020507" pitchFamily="18" charset="2"/>
                  </a:rPr>
                  <a:t>b</a:t>
                </a:r>
                <a:r>
                  <a:rPr lang="en-US" altLang="ko-KR" sz="1400" dirty="0"/>
                  <a:t>-actin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 * denotes that the response is significantly different from mock-treated group as determined by </a:t>
                </a:r>
                <a:r>
                  <a:rPr lang="en-US" altLang="ko-KR" sz="1400" dirty="0" err="1"/>
                  <a:t>Dunnett’s</a:t>
                </a:r>
                <a:r>
                  <a:rPr lang="en-US" altLang="ko-KR" sz="1400" dirty="0"/>
                  <a:t> t-test at p&lt;0.05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76" name="TextBox 75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5439956"/>
                <a:ext cx="8856984" cy="1384995"/>
              </a:xfrm>
              <a:prstGeom prst="rect">
                <a:avLst/>
              </a:prstGeom>
              <a:blipFill>
                <a:blip r:embed="rId6"/>
                <a:stretch>
                  <a:fillRect l="-206" t="-439" r="-206" b="-350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42249060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45781" y="1566084"/>
            <a:ext cx="2914372" cy="1871933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8333" y="1577659"/>
            <a:ext cx="3001075" cy="18719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282596" y="1945945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994736" y="3368567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63528" y="3518446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61689" y="3666877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iVDUP1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810746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291879" y="33685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756480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244070" y="3518446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291470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713045" y="3518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340001" y="351844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342898" y="366687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814090" y="351514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293505" y="366687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13429" y="36668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5714503" y="3515929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767893" y="36797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194364" y="119903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057384" y="11967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896194" y="3368567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64986" y="3518446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63147" y="3666877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iVDUP1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712204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193337" y="33685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657938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145528" y="3518446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192928" y="336856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614503" y="351844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241459" y="351844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244356" y="366687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715548" y="351514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194963" y="3666877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614887" y="366687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1627536" y="3515929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669351" y="36797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192273" y="1850787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51" name="TextBox 50"/>
              <p:cNvSpPr txBox="1"/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5. </a:t>
                </a:r>
                <a:r>
                  <a:rPr lang="en-US" altLang="ko-KR" sz="1400" dirty="0"/>
                  <a:t>The effects of dsVDUP1-834 on p27 and p53 expression were attenuated by VDUP1 siRNA in A549 cells. A549 cells were transfected with </a:t>
                </a:r>
                <a:r>
                  <a:rPr lang="en-US" altLang="ko-KR" sz="1400" dirty="0" err="1"/>
                  <a:t>dsCon</a:t>
                </a:r>
                <a:r>
                  <a:rPr lang="en-US" altLang="ko-KR" sz="1400" dirty="0"/>
                  <a:t> or indicated concentrations of </a:t>
                </a:r>
                <a:r>
                  <a:rPr lang="en-US" altLang="ko-KR" sz="1400" dirty="0" err="1"/>
                  <a:t>saRNAs</a:t>
                </a:r>
                <a:r>
                  <a:rPr lang="en-US" altLang="ko-KR" sz="1400" dirty="0"/>
                  <a:t> for 96 h. The protein expression of p27(A) and p53(B) was assessed by Western immunoblot analysis. The band intensities were quantified by </a:t>
                </a:r>
                <a:r>
                  <a:rPr lang="en-US" altLang="ko-KR" sz="1400" dirty="0" err="1"/>
                  <a:t>ImageJ</a:t>
                </a:r>
                <a:r>
                  <a:rPr lang="en-US" altLang="ko-KR" sz="1400" dirty="0"/>
                  <a:t> 1.53a and normalized by that of </a:t>
                </a:r>
                <a:r>
                  <a:rPr lang="en-US" altLang="ko-KR" sz="1400" dirty="0">
                    <a:latin typeface="Symbol" panose="05050102010706020507" pitchFamily="18" charset="2"/>
                  </a:rPr>
                  <a:t>b</a:t>
                </a:r>
                <a:r>
                  <a:rPr lang="en-US" altLang="ko-KR" sz="1400" dirty="0"/>
                  <a:t>-actin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 * denotes that the response is significantly different from mock-treated group as determined by </a:t>
                </a:r>
                <a:r>
                  <a:rPr lang="en-US" altLang="ko-KR" sz="1400" dirty="0" err="1"/>
                  <a:t>Dunnett’s</a:t>
                </a:r>
                <a:r>
                  <a:rPr lang="en-US" altLang="ko-KR" sz="1400" dirty="0"/>
                  <a:t> t-test at p&lt;0.05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51" name="TextBox 50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blipFill>
                <a:blip r:embed="rId4"/>
                <a:stretch>
                  <a:fillRect l="-206" t="-881" r="-206" b="-35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4854235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41962" y="1628089"/>
            <a:ext cx="2932996" cy="178922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9316" y="1562507"/>
            <a:ext cx="3007503" cy="1877956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7282596" y="1878940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994736" y="3371012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63528" y="3520891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967486" y="3669322"/>
            <a:ext cx="9188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iAgo2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810746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291879" y="33710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756480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244070" y="3520891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291470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713045" y="3520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340001" y="35208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342898" y="366932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814090" y="351758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293505" y="366932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713429" y="3669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5714503" y="3518374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767893" y="36821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194364" y="12014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057384" y="119919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896194" y="3371012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Con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64986" y="3520891"/>
            <a:ext cx="1322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sVDUP1-834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868944" y="3669322"/>
            <a:ext cx="9188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siAgo2 (n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700629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193337" y="33710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657938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133953" y="3520891"/>
            <a:ext cx="325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181353" y="337101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614503" y="352089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241459" y="3520891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244356" y="366932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703973" y="3517586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183388" y="3669322"/>
            <a:ext cx="2279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614887" y="3669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6200000">
            <a:off x="1627536" y="3518374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657776" y="36821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189715" y="1804979"/>
            <a:ext cx="199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42" name="TextBox 41"/>
              <p:cNvSpPr txBox="1"/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400" b="1" dirty="0"/>
                  <a:t>Supplementary Figure S6. </a:t>
                </a:r>
                <a:r>
                  <a:rPr lang="en-US" altLang="ko-KR" sz="1400" dirty="0"/>
                  <a:t>The effects of dsVDUP1-834 on p27 and p53 expression were attenuated by Ago2 siRNA in A549 cells. A549 cells were transfected with </a:t>
                </a:r>
                <a:r>
                  <a:rPr lang="en-US" altLang="ko-KR" sz="1400" dirty="0" err="1"/>
                  <a:t>dsCon</a:t>
                </a:r>
                <a:r>
                  <a:rPr lang="en-US" altLang="ko-KR" sz="1400" dirty="0"/>
                  <a:t> or indicated concentrations of </a:t>
                </a:r>
                <a:r>
                  <a:rPr lang="en-US" altLang="ko-KR" sz="1400" dirty="0" err="1"/>
                  <a:t>saRNAs</a:t>
                </a:r>
                <a:r>
                  <a:rPr lang="en-US" altLang="ko-KR" sz="1400" dirty="0"/>
                  <a:t> for 96 h. The protein expression of p27(A) and p53(B) was assessed by Western immunoblot analysis. The band intensities were quantified by </a:t>
                </a:r>
                <a:r>
                  <a:rPr lang="en-US" altLang="ko-KR" sz="1400" dirty="0" err="1"/>
                  <a:t>ImageJ</a:t>
                </a:r>
                <a:r>
                  <a:rPr lang="en-US" altLang="ko-KR" sz="1400" dirty="0"/>
                  <a:t> 1.53a and normalized by that of </a:t>
                </a:r>
                <a:r>
                  <a:rPr lang="en-US" altLang="ko-KR" sz="1400" dirty="0">
                    <a:latin typeface="Symbol" panose="05050102010706020507" pitchFamily="18" charset="2"/>
                  </a:rPr>
                  <a:t>b</a:t>
                </a:r>
                <a:r>
                  <a:rPr lang="en-US" altLang="ko-KR" sz="1400" dirty="0"/>
                  <a:t>-actin. The data are represented as mean </a:t>
                </a:r>
                <a14:m>
                  <m:oMath xmlns:m="http://schemas.openxmlformats.org/officeDocument/2006/math">
                    <m:r>
                      <a:rPr lang="en-US" altLang="ko-KR" sz="1400" b="0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± </m:t>
                    </m:r>
                  </m:oMath>
                </a14:m>
                <a:r>
                  <a:rPr lang="en-US" altLang="ko-KR" sz="1400" dirty="0"/>
                  <a:t>S.D. of triplicate determinations. * denotes that the response is significantly different from mock-treated group as determined by </a:t>
                </a:r>
                <a:r>
                  <a:rPr lang="en-US" altLang="ko-KR" sz="1400" dirty="0" err="1"/>
                  <a:t>Dunnett’s</a:t>
                </a:r>
                <a:r>
                  <a:rPr lang="en-US" altLang="ko-KR" sz="1400" dirty="0"/>
                  <a:t> t-test at p&lt;0.05.</a:t>
                </a:r>
                <a:endParaRPr lang="ko-KR" altLang="en-US" sz="1400" dirty="0"/>
              </a:p>
            </p:txBody>
          </p:sp>
        </mc:Choice>
        <mc:Fallback>
          <p:sp>
            <p:nvSpPr>
              <p:cNvPr id="42" name="TextBox 4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44344" y="4880735"/>
                <a:ext cx="8856984" cy="1384995"/>
              </a:xfrm>
              <a:prstGeom prst="rect">
                <a:avLst/>
              </a:prstGeom>
              <a:blipFill>
                <a:blip r:embed="rId4"/>
                <a:stretch>
                  <a:fillRect l="-206" t="-881" r="-206" b="-35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210010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</TotalTime>
  <Words>789</Words>
  <Application>Microsoft Office PowerPoint</Application>
  <PresentationFormat>On-screen Show (4:3)</PresentationFormat>
  <Paragraphs>16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맑은 고딕</vt:lpstr>
      <vt:lpstr>Arial</vt:lpstr>
      <vt:lpstr>Cambria Math</vt:lpstr>
      <vt:lpstr>Symbol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59</cp:revision>
  <dcterms:created xsi:type="dcterms:W3CDTF">2014-11-25T15:22:07Z</dcterms:created>
  <dcterms:modified xsi:type="dcterms:W3CDTF">2022-07-12T10:21:15Z</dcterms:modified>
</cp:coreProperties>
</file>